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0" r:id="rId1"/>
  </p:sldMasterIdLst>
  <p:notesMasterIdLst>
    <p:notesMasterId r:id="rId10"/>
  </p:notesMasterIdLst>
  <p:sldIdLst>
    <p:sldId id="259" r:id="rId2"/>
    <p:sldId id="260" r:id="rId3"/>
    <p:sldId id="261" r:id="rId4"/>
    <p:sldId id="262" r:id="rId5"/>
    <p:sldId id="263" r:id="rId6"/>
    <p:sldId id="264" r:id="rId7"/>
    <p:sldId id="265" r:id="rId8"/>
    <p:sldId id="266" r:id="rId9"/>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58E8BEE-47DD-4E8E-9E49-47EA329772BC}" v="50" dt="2025-12-16T08:44:14.98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658" autoAdjust="0"/>
    <p:restoredTop sz="94660"/>
  </p:normalViewPr>
  <p:slideViewPr>
    <p:cSldViewPr snapToGrid="0">
      <p:cViewPr varScale="1">
        <p:scale>
          <a:sx n="105" d="100"/>
          <a:sy n="105" d="100"/>
        </p:scale>
        <p:origin x="1830"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ilek Joel" userId="6eced431-8616-4256-9a11-6ac8affbd2df" providerId="ADAL" clId="{C8CC9B49-3A7E-4747-AB42-3F51622577EC}"/>
    <pc:docChg chg="custSel addSld delSld modSld">
      <pc:chgData name="Milek Joel" userId="6eced431-8616-4256-9a11-6ac8affbd2df" providerId="ADAL" clId="{C8CC9B49-3A7E-4747-AB42-3F51622577EC}" dt="2025-10-28T09:00:42.880" v="195" actId="47"/>
      <pc:docMkLst>
        <pc:docMk/>
      </pc:docMkLst>
      <pc:sldChg chg="addSp delSp modSp mod">
        <pc:chgData name="Milek Joel" userId="6eced431-8616-4256-9a11-6ac8affbd2df" providerId="ADAL" clId="{C8CC9B49-3A7E-4747-AB42-3F51622577EC}" dt="2025-10-27T14:34:47.931" v="170"/>
        <pc:sldMkLst>
          <pc:docMk/>
          <pc:sldMk cId="1348719653" sldId="259"/>
        </pc:sldMkLst>
        <pc:spChg chg="add mod">
          <ac:chgData name="Milek Joel" userId="6eced431-8616-4256-9a11-6ac8affbd2df" providerId="ADAL" clId="{C8CC9B49-3A7E-4747-AB42-3F51622577EC}" dt="2025-10-27T14:34:47.931" v="170"/>
          <ac:spMkLst>
            <pc:docMk/>
            <pc:sldMk cId="1348719653" sldId="259"/>
            <ac:spMk id="2" creationId="{95C9FF4F-6E34-8AC2-0691-84A6AF49ACAA}"/>
          </ac:spMkLst>
        </pc:spChg>
      </pc:sldChg>
      <pc:sldChg chg="addSp delSp modSp add mod">
        <pc:chgData name="Milek Joel" userId="6eced431-8616-4256-9a11-6ac8affbd2df" providerId="ADAL" clId="{C8CC9B49-3A7E-4747-AB42-3F51622577EC}" dt="2025-10-27T14:34:47.931" v="170"/>
        <pc:sldMkLst>
          <pc:docMk/>
          <pc:sldMk cId="1438807616" sldId="260"/>
        </pc:sldMkLst>
        <pc:spChg chg="mod">
          <ac:chgData name="Milek Joel" userId="6eced431-8616-4256-9a11-6ac8affbd2df" providerId="ADAL" clId="{C8CC9B49-3A7E-4747-AB42-3F51622577EC}" dt="2025-10-27T14:34:47.931" v="170"/>
          <ac:spMkLst>
            <pc:docMk/>
            <pc:sldMk cId="1438807616" sldId="260"/>
            <ac:spMk id="11" creationId="{B277BAB5-9A7E-0572-06F2-B0CF368C40BF}"/>
          </ac:spMkLst>
        </pc:spChg>
      </pc:sldChg>
      <pc:sldChg chg="addSp delSp modSp add mod">
        <pc:chgData name="Milek Joel" userId="6eced431-8616-4256-9a11-6ac8affbd2df" providerId="ADAL" clId="{C8CC9B49-3A7E-4747-AB42-3F51622577EC}" dt="2025-10-27T14:34:47.931" v="170"/>
        <pc:sldMkLst>
          <pc:docMk/>
          <pc:sldMk cId="3288457707" sldId="261"/>
        </pc:sldMkLst>
        <pc:spChg chg="mod">
          <ac:chgData name="Milek Joel" userId="6eced431-8616-4256-9a11-6ac8affbd2df" providerId="ADAL" clId="{C8CC9B49-3A7E-4747-AB42-3F51622577EC}" dt="2025-10-27T14:34:47.931" v="170"/>
          <ac:spMkLst>
            <pc:docMk/>
            <pc:sldMk cId="3288457707" sldId="261"/>
            <ac:spMk id="11" creationId="{BD1A018C-A669-B098-F971-00A3A859B060}"/>
          </ac:spMkLst>
        </pc:spChg>
      </pc:sldChg>
      <pc:sldChg chg="new del">
        <pc:chgData name="Milek Joel" userId="6eced431-8616-4256-9a11-6ac8affbd2df" providerId="ADAL" clId="{C8CC9B49-3A7E-4747-AB42-3F51622577EC}" dt="2025-10-15T10:52:35.849" v="52" actId="47"/>
        <pc:sldMkLst>
          <pc:docMk/>
          <pc:sldMk cId="2227380491" sldId="262"/>
        </pc:sldMkLst>
      </pc:sldChg>
      <pc:sldChg chg="addSp delSp modSp add mod">
        <pc:chgData name="Milek Joel" userId="6eced431-8616-4256-9a11-6ac8affbd2df" providerId="ADAL" clId="{C8CC9B49-3A7E-4747-AB42-3F51622577EC}" dt="2025-10-27T14:34:47.931" v="170"/>
        <pc:sldMkLst>
          <pc:docMk/>
          <pc:sldMk cId="3983763980" sldId="262"/>
        </pc:sldMkLst>
        <pc:spChg chg="mod">
          <ac:chgData name="Milek Joel" userId="6eced431-8616-4256-9a11-6ac8affbd2df" providerId="ADAL" clId="{C8CC9B49-3A7E-4747-AB42-3F51622577EC}" dt="2025-10-27T14:34:47.931" v="170"/>
          <ac:spMkLst>
            <pc:docMk/>
            <pc:sldMk cId="3983763980" sldId="262"/>
            <ac:spMk id="11" creationId="{DA131EDF-EC6B-C484-9218-537735E4388C}"/>
          </ac:spMkLst>
        </pc:spChg>
      </pc:sldChg>
      <pc:sldChg chg="addSp delSp modSp add mod">
        <pc:chgData name="Milek Joel" userId="6eced431-8616-4256-9a11-6ac8affbd2df" providerId="ADAL" clId="{C8CC9B49-3A7E-4747-AB42-3F51622577EC}" dt="2025-10-27T14:34:47.931" v="170"/>
        <pc:sldMkLst>
          <pc:docMk/>
          <pc:sldMk cId="1815334448" sldId="263"/>
        </pc:sldMkLst>
        <pc:spChg chg="mod">
          <ac:chgData name="Milek Joel" userId="6eced431-8616-4256-9a11-6ac8affbd2df" providerId="ADAL" clId="{C8CC9B49-3A7E-4747-AB42-3F51622577EC}" dt="2025-10-27T14:34:47.931" v="170"/>
          <ac:spMkLst>
            <pc:docMk/>
            <pc:sldMk cId="1815334448" sldId="263"/>
            <ac:spMk id="11" creationId="{F69B3333-07E9-BD71-1C1D-B3FA7EF6A4C5}"/>
          </ac:spMkLst>
        </pc:spChg>
      </pc:sldChg>
      <pc:sldChg chg="addSp delSp modSp add mod">
        <pc:chgData name="Milek Joel" userId="6eced431-8616-4256-9a11-6ac8affbd2df" providerId="ADAL" clId="{C8CC9B49-3A7E-4747-AB42-3F51622577EC}" dt="2025-10-27T14:34:47.931" v="170"/>
        <pc:sldMkLst>
          <pc:docMk/>
          <pc:sldMk cId="3857761132" sldId="264"/>
        </pc:sldMkLst>
        <pc:spChg chg="mod">
          <ac:chgData name="Milek Joel" userId="6eced431-8616-4256-9a11-6ac8affbd2df" providerId="ADAL" clId="{C8CC9B49-3A7E-4747-AB42-3F51622577EC}" dt="2025-10-27T14:34:47.931" v="170"/>
          <ac:spMkLst>
            <pc:docMk/>
            <pc:sldMk cId="3857761132" sldId="264"/>
            <ac:spMk id="11" creationId="{06463492-DF91-9630-8419-05B7F3B165AE}"/>
          </ac:spMkLst>
        </pc:spChg>
      </pc:sldChg>
      <pc:sldChg chg="addSp delSp modSp new del mod">
        <pc:chgData name="Milek Joel" userId="6eced431-8616-4256-9a11-6ac8affbd2df" providerId="ADAL" clId="{C8CC9B49-3A7E-4747-AB42-3F51622577EC}" dt="2025-10-28T09:00:42.880" v="195" actId="47"/>
        <pc:sldMkLst>
          <pc:docMk/>
          <pc:sldMk cId="1119455785" sldId="265"/>
        </pc:sldMkLst>
      </pc:sldChg>
      <pc:sldChg chg="addSp delSp modSp new del mod">
        <pc:chgData name="Milek Joel" userId="6eced431-8616-4256-9a11-6ac8affbd2df" providerId="ADAL" clId="{C8CC9B49-3A7E-4747-AB42-3F51622577EC}" dt="2025-10-21T11:04:44.193" v="169" actId="47"/>
        <pc:sldMkLst>
          <pc:docMk/>
          <pc:sldMk cId="4280307807" sldId="265"/>
        </pc:sldMkLst>
      </pc:sldChg>
    </pc:docChg>
  </pc:docChgLst>
  <pc:docChgLst>
    <pc:chgData name="Milek Joel" userId="6eced431-8616-4256-9a11-6ac8affbd2df" providerId="ADAL" clId="{558E8BEE-47DD-4E8E-9E49-47EA329772BC}"/>
    <pc:docChg chg="undo custSel addSld modSld">
      <pc:chgData name="Milek Joel" userId="6eced431-8616-4256-9a11-6ac8affbd2df" providerId="ADAL" clId="{558E8BEE-47DD-4E8E-9E49-47EA329772BC}" dt="2025-12-16T08:44:14.984" v="268"/>
      <pc:docMkLst>
        <pc:docMk/>
      </pc:docMkLst>
      <pc:sldChg chg="addSp delSp modSp mod">
        <pc:chgData name="Milek Joel" userId="6eced431-8616-4256-9a11-6ac8affbd2df" providerId="ADAL" clId="{558E8BEE-47DD-4E8E-9E49-47EA329772BC}" dt="2025-12-15T09:36:05.934" v="167" actId="20578"/>
        <pc:sldMkLst>
          <pc:docMk/>
          <pc:sldMk cId="1348719653" sldId="259"/>
        </pc:sldMkLst>
        <pc:spChg chg="mod">
          <ac:chgData name="Milek Joel" userId="6eced431-8616-4256-9a11-6ac8affbd2df" providerId="ADAL" clId="{558E8BEE-47DD-4E8E-9E49-47EA329772BC}" dt="2025-12-15T09:36:05.934" v="167" actId="20578"/>
          <ac:spMkLst>
            <pc:docMk/>
            <pc:sldMk cId="1348719653" sldId="259"/>
            <ac:spMk id="2" creationId="{95C9FF4F-6E34-8AC2-0691-84A6AF49ACAA}"/>
          </ac:spMkLst>
        </pc:spChg>
        <pc:picChg chg="add mod">
          <ac:chgData name="Milek Joel" userId="6eced431-8616-4256-9a11-6ac8affbd2df" providerId="ADAL" clId="{558E8BEE-47DD-4E8E-9E49-47EA329772BC}" dt="2025-12-13T14:09:53.157" v="3" actId="27614"/>
          <ac:picMkLst>
            <pc:docMk/>
            <pc:sldMk cId="1348719653" sldId="259"/>
            <ac:picMk id="4" creationId="{2C8A07FE-3F00-7955-BD1A-BDC298A6A810}"/>
          </ac:picMkLst>
        </pc:picChg>
      </pc:sldChg>
      <pc:sldChg chg="addSp delSp modSp mod">
        <pc:chgData name="Milek Joel" userId="6eced431-8616-4256-9a11-6ac8affbd2df" providerId="ADAL" clId="{558E8BEE-47DD-4E8E-9E49-47EA329772BC}" dt="2025-12-15T09:36:17.218" v="168"/>
        <pc:sldMkLst>
          <pc:docMk/>
          <pc:sldMk cId="1438807616" sldId="260"/>
        </pc:sldMkLst>
        <pc:spChg chg="mod">
          <ac:chgData name="Milek Joel" userId="6eced431-8616-4256-9a11-6ac8affbd2df" providerId="ADAL" clId="{558E8BEE-47DD-4E8E-9E49-47EA329772BC}" dt="2025-12-15T09:36:17.218" v="168"/>
          <ac:spMkLst>
            <pc:docMk/>
            <pc:sldMk cId="1438807616" sldId="260"/>
            <ac:spMk id="11" creationId="{B277BAB5-9A7E-0572-06F2-B0CF368C40BF}"/>
          </ac:spMkLst>
        </pc:spChg>
        <pc:picChg chg="add mod">
          <ac:chgData name="Milek Joel" userId="6eced431-8616-4256-9a11-6ac8affbd2df" providerId="ADAL" clId="{558E8BEE-47DD-4E8E-9E49-47EA329772BC}" dt="2025-12-13T14:10:35.604" v="10" actId="1076"/>
          <ac:picMkLst>
            <pc:docMk/>
            <pc:sldMk cId="1438807616" sldId="260"/>
            <ac:picMk id="4" creationId="{8EB91D89-8803-440B-4DA0-EAA3046E7BEC}"/>
          </ac:picMkLst>
        </pc:picChg>
      </pc:sldChg>
      <pc:sldChg chg="addSp delSp modSp mod">
        <pc:chgData name="Milek Joel" userId="6eced431-8616-4256-9a11-6ac8affbd2df" providerId="ADAL" clId="{558E8BEE-47DD-4E8E-9E49-47EA329772BC}" dt="2025-12-15T09:36:20.126" v="169"/>
        <pc:sldMkLst>
          <pc:docMk/>
          <pc:sldMk cId="3288457707" sldId="261"/>
        </pc:sldMkLst>
        <pc:spChg chg="mod">
          <ac:chgData name="Milek Joel" userId="6eced431-8616-4256-9a11-6ac8affbd2df" providerId="ADAL" clId="{558E8BEE-47DD-4E8E-9E49-47EA329772BC}" dt="2025-12-15T09:36:20.126" v="169"/>
          <ac:spMkLst>
            <pc:docMk/>
            <pc:sldMk cId="3288457707" sldId="261"/>
            <ac:spMk id="11" creationId="{BD1A018C-A669-B098-F971-00A3A859B060}"/>
          </ac:spMkLst>
        </pc:spChg>
        <pc:picChg chg="add mod">
          <ac:chgData name="Milek Joel" userId="6eced431-8616-4256-9a11-6ac8affbd2df" providerId="ADAL" clId="{558E8BEE-47DD-4E8E-9E49-47EA329772BC}" dt="2025-12-13T14:11:02.235" v="15" actId="1076"/>
          <ac:picMkLst>
            <pc:docMk/>
            <pc:sldMk cId="3288457707" sldId="261"/>
            <ac:picMk id="3" creationId="{21158876-9140-E417-D915-D4AF8FAE03BE}"/>
          </ac:picMkLst>
        </pc:picChg>
      </pc:sldChg>
      <pc:sldChg chg="addSp delSp modSp mod">
        <pc:chgData name="Milek Joel" userId="6eced431-8616-4256-9a11-6ac8affbd2df" providerId="ADAL" clId="{558E8BEE-47DD-4E8E-9E49-47EA329772BC}" dt="2025-12-15T09:36:28.373" v="170"/>
        <pc:sldMkLst>
          <pc:docMk/>
          <pc:sldMk cId="3983763980" sldId="262"/>
        </pc:sldMkLst>
        <pc:spChg chg="mod">
          <ac:chgData name="Milek Joel" userId="6eced431-8616-4256-9a11-6ac8affbd2df" providerId="ADAL" clId="{558E8BEE-47DD-4E8E-9E49-47EA329772BC}" dt="2025-12-15T09:36:28.373" v="170"/>
          <ac:spMkLst>
            <pc:docMk/>
            <pc:sldMk cId="3983763980" sldId="262"/>
            <ac:spMk id="11" creationId="{DA131EDF-EC6B-C484-9218-537735E4388C}"/>
          </ac:spMkLst>
        </pc:spChg>
        <pc:picChg chg="add mod">
          <ac:chgData name="Milek Joel" userId="6eced431-8616-4256-9a11-6ac8affbd2df" providerId="ADAL" clId="{558E8BEE-47DD-4E8E-9E49-47EA329772BC}" dt="2025-12-13T14:11:27.504" v="20" actId="1076"/>
          <ac:picMkLst>
            <pc:docMk/>
            <pc:sldMk cId="3983763980" sldId="262"/>
            <ac:picMk id="3" creationId="{8ECFD058-BE7D-7284-F46B-7DB129E56188}"/>
          </ac:picMkLst>
        </pc:picChg>
      </pc:sldChg>
      <pc:sldChg chg="addSp delSp modSp mod">
        <pc:chgData name="Milek Joel" userId="6eced431-8616-4256-9a11-6ac8affbd2df" providerId="ADAL" clId="{558E8BEE-47DD-4E8E-9E49-47EA329772BC}" dt="2025-12-15T09:36:31.878" v="171"/>
        <pc:sldMkLst>
          <pc:docMk/>
          <pc:sldMk cId="1815334448" sldId="263"/>
        </pc:sldMkLst>
        <pc:spChg chg="mod">
          <ac:chgData name="Milek Joel" userId="6eced431-8616-4256-9a11-6ac8affbd2df" providerId="ADAL" clId="{558E8BEE-47DD-4E8E-9E49-47EA329772BC}" dt="2025-12-15T09:36:31.878" v="171"/>
          <ac:spMkLst>
            <pc:docMk/>
            <pc:sldMk cId="1815334448" sldId="263"/>
            <ac:spMk id="11" creationId="{F69B3333-07E9-BD71-1C1D-B3FA7EF6A4C5}"/>
          </ac:spMkLst>
        </pc:spChg>
        <pc:picChg chg="add mod">
          <ac:chgData name="Milek Joel" userId="6eced431-8616-4256-9a11-6ac8affbd2df" providerId="ADAL" clId="{558E8BEE-47DD-4E8E-9E49-47EA329772BC}" dt="2025-12-13T14:11:45.250" v="25" actId="1076"/>
          <ac:picMkLst>
            <pc:docMk/>
            <pc:sldMk cId="1815334448" sldId="263"/>
            <ac:picMk id="4" creationId="{2901D450-4414-9FF0-F035-461F60D1E866}"/>
          </ac:picMkLst>
        </pc:picChg>
      </pc:sldChg>
      <pc:sldChg chg="addSp delSp modSp mod">
        <pc:chgData name="Milek Joel" userId="6eced431-8616-4256-9a11-6ac8affbd2df" providerId="ADAL" clId="{558E8BEE-47DD-4E8E-9E49-47EA329772BC}" dt="2025-12-15T09:36:35.047" v="172"/>
        <pc:sldMkLst>
          <pc:docMk/>
          <pc:sldMk cId="3857761132" sldId="264"/>
        </pc:sldMkLst>
        <pc:spChg chg="mod">
          <ac:chgData name="Milek Joel" userId="6eced431-8616-4256-9a11-6ac8affbd2df" providerId="ADAL" clId="{558E8BEE-47DD-4E8E-9E49-47EA329772BC}" dt="2025-12-15T09:36:35.047" v="172"/>
          <ac:spMkLst>
            <pc:docMk/>
            <pc:sldMk cId="3857761132" sldId="264"/>
            <ac:spMk id="11" creationId="{06463492-DF91-9630-8419-05B7F3B165AE}"/>
          </ac:spMkLst>
        </pc:spChg>
        <pc:picChg chg="add mod">
          <ac:chgData name="Milek Joel" userId="6eced431-8616-4256-9a11-6ac8affbd2df" providerId="ADAL" clId="{558E8BEE-47DD-4E8E-9E49-47EA329772BC}" dt="2025-12-13T14:12:35.581" v="39" actId="1076"/>
          <ac:picMkLst>
            <pc:docMk/>
            <pc:sldMk cId="3857761132" sldId="264"/>
            <ac:picMk id="6" creationId="{CED2C8BC-74DF-38BD-FA74-300A84EB78FA}"/>
          </ac:picMkLst>
        </pc:picChg>
      </pc:sldChg>
      <pc:sldChg chg="addSp delSp modSp new mod">
        <pc:chgData name="Milek Joel" userId="6eced431-8616-4256-9a11-6ac8affbd2df" providerId="ADAL" clId="{558E8BEE-47DD-4E8E-9E49-47EA329772BC}" dt="2025-12-16T08:43:57.279" v="266"/>
        <pc:sldMkLst>
          <pc:docMk/>
          <pc:sldMk cId="1817468911" sldId="265"/>
        </pc:sldMkLst>
        <pc:spChg chg="add mod">
          <ac:chgData name="Milek Joel" userId="6eced431-8616-4256-9a11-6ac8affbd2df" providerId="ADAL" clId="{558E8BEE-47DD-4E8E-9E49-47EA329772BC}" dt="2025-12-16T08:43:57.279" v="266"/>
          <ac:spMkLst>
            <pc:docMk/>
            <pc:sldMk cId="1817468911" sldId="265"/>
            <ac:spMk id="5" creationId="{91670905-630A-F747-049E-7BCC5FE6BBA5}"/>
          </ac:spMkLst>
        </pc:spChg>
        <pc:picChg chg="add del mod">
          <ac:chgData name="Milek Joel" userId="6eced431-8616-4256-9a11-6ac8affbd2df" providerId="ADAL" clId="{558E8BEE-47DD-4E8E-9E49-47EA329772BC}" dt="2025-12-15T11:54:33.771" v="180" actId="478"/>
          <ac:picMkLst>
            <pc:docMk/>
            <pc:sldMk cId="1817468911" sldId="265"/>
            <ac:picMk id="3" creationId="{6B9AB7CA-5C0F-1783-9E01-F3E2A29A3294}"/>
          </ac:picMkLst>
        </pc:picChg>
        <pc:picChg chg="add mod">
          <ac:chgData name="Milek Joel" userId="6eced431-8616-4256-9a11-6ac8affbd2df" providerId="ADAL" clId="{558E8BEE-47DD-4E8E-9E49-47EA329772BC}" dt="2025-12-15T11:55:01.482" v="188" actId="1076"/>
          <ac:picMkLst>
            <pc:docMk/>
            <pc:sldMk cId="1817468911" sldId="265"/>
            <ac:picMk id="4" creationId="{DDC25600-5E0D-6101-643A-8369BB8CB60F}"/>
          </ac:picMkLst>
        </pc:picChg>
      </pc:sldChg>
      <pc:sldChg chg="addSp delSp modSp new mod">
        <pc:chgData name="Milek Joel" userId="6eced431-8616-4256-9a11-6ac8affbd2df" providerId="ADAL" clId="{558E8BEE-47DD-4E8E-9E49-47EA329772BC}" dt="2025-12-16T08:44:14.984" v="268"/>
        <pc:sldMkLst>
          <pc:docMk/>
          <pc:sldMk cId="2690825949" sldId="266"/>
        </pc:sldMkLst>
        <pc:spChg chg="add mod">
          <ac:chgData name="Milek Joel" userId="6eced431-8616-4256-9a11-6ac8affbd2df" providerId="ADAL" clId="{558E8BEE-47DD-4E8E-9E49-47EA329772BC}" dt="2025-12-16T08:44:14.984" v="268"/>
          <ac:spMkLst>
            <pc:docMk/>
            <pc:sldMk cId="2690825949" sldId="266"/>
            <ac:spMk id="4" creationId="{AE8D3AB9-5EFA-62C9-CA4A-B74C0B6BAB4A}"/>
          </ac:spMkLst>
        </pc:spChg>
        <pc:picChg chg="add del mod">
          <ac:chgData name="Milek Joel" userId="6eced431-8616-4256-9a11-6ac8affbd2df" providerId="ADAL" clId="{558E8BEE-47DD-4E8E-9E49-47EA329772BC}" dt="2025-12-15T11:54:02.140" v="173" actId="478"/>
          <ac:picMkLst>
            <pc:docMk/>
            <pc:sldMk cId="2690825949" sldId="266"/>
            <ac:picMk id="3" creationId="{5D9C239B-1292-8BE3-A118-E67B54A8DE67}"/>
          </ac:picMkLst>
        </pc:picChg>
        <pc:picChg chg="add mod">
          <ac:chgData name="Milek Joel" userId="6eced431-8616-4256-9a11-6ac8affbd2df" providerId="ADAL" clId="{558E8BEE-47DD-4E8E-9E49-47EA329772BC}" dt="2025-12-15T11:54:22.852" v="179" actId="1076"/>
          <ac:picMkLst>
            <pc:docMk/>
            <pc:sldMk cId="2690825949" sldId="266"/>
            <ac:picMk id="5" creationId="{523720E9-E453-6F60-3B21-E93E1A8807F4}"/>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7546694-7CAA-4617-8145-1F0BD8700913}" type="datetimeFigureOut">
              <a:rPr lang="de-DE" smtClean="0"/>
              <a:t>16.12.2025</a:t>
            </a:fld>
            <a:endParaRPr lang="de-DE"/>
          </a:p>
        </p:txBody>
      </p:sp>
      <p:sp>
        <p:nvSpPr>
          <p:cNvPr id="4" name="Folienbildplatzhalt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E1B8FA0-7912-41B4-BA39-4A129DCAD8C8}" type="slidenum">
              <a:rPr lang="de-DE" smtClean="0"/>
              <a:t>‹Nr.›</a:t>
            </a:fld>
            <a:endParaRPr lang="de-DE"/>
          </a:p>
        </p:txBody>
      </p:sp>
    </p:spTree>
    <p:extLst>
      <p:ext uri="{BB962C8B-B14F-4D97-AF65-F5344CB8AC3E}">
        <p14:creationId xmlns:p14="http://schemas.microsoft.com/office/powerpoint/2010/main" val="11508661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dirty="0"/>
          </a:p>
        </p:txBody>
      </p:sp>
      <p:sp>
        <p:nvSpPr>
          <p:cNvPr id="4" name="Foliennummernplatzhalter 3"/>
          <p:cNvSpPr>
            <a:spLocks noGrp="1"/>
          </p:cNvSpPr>
          <p:nvPr>
            <p:ph type="sldNum" sz="quarter" idx="5"/>
          </p:nvPr>
        </p:nvSpPr>
        <p:spPr/>
        <p:txBody>
          <a:bodyPr/>
          <a:lstStyle/>
          <a:p>
            <a:fld id="{FE1B8FA0-7912-41B4-BA39-4A129DCAD8C8}" type="slidenum">
              <a:rPr lang="de-DE" smtClean="0"/>
              <a:t>1</a:t>
            </a:fld>
            <a:endParaRPr lang="de-DE"/>
          </a:p>
        </p:txBody>
      </p:sp>
    </p:spTree>
    <p:extLst>
      <p:ext uri="{BB962C8B-B14F-4D97-AF65-F5344CB8AC3E}">
        <p14:creationId xmlns:p14="http://schemas.microsoft.com/office/powerpoint/2010/main" val="40265290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de-DE"/>
              <a:t>Mastertitelformat bearbeiten</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68748096-5A3E-4ED9-A564-DF9D8AE910A3}" type="datetimeFigureOut">
              <a:rPr lang="de-DE" smtClean="0"/>
              <a:t>16.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42864176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8748096-5A3E-4ED9-A564-DF9D8AE910A3}" type="datetimeFigureOut">
              <a:rPr lang="de-DE" smtClean="0"/>
              <a:t>16.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27298318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8748096-5A3E-4ED9-A564-DF9D8AE910A3}" type="datetimeFigureOut">
              <a:rPr lang="de-DE" smtClean="0"/>
              <a:t>16.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8974727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68748096-5A3E-4ED9-A564-DF9D8AE910A3}" type="datetimeFigureOut">
              <a:rPr lang="de-DE" smtClean="0"/>
              <a:t>16.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32436666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de-DE"/>
              <a:t>Mastertitelformat bearbeiten</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68748096-5A3E-4ED9-A564-DF9D8AE910A3}" type="datetimeFigureOut">
              <a:rPr lang="de-DE" smtClean="0"/>
              <a:t>16.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3140690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68748096-5A3E-4ED9-A564-DF9D8AE910A3}" type="datetimeFigureOut">
              <a:rPr lang="de-DE" smtClean="0"/>
              <a:t>16.1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26519664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de-DE"/>
              <a:t>Mastertitelformat bearbeiten</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Content Placeholder 3"/>
          <p:cNvSpPr>
            <a:spLocks noGrp="1"/>
          </p:cNvSpPr>
          <p:nvPr>
            <p:ph sz="half" idx="2"/>
          </p:nvPr>
        </p:nvSpPr>
        <p:spPr>
          <a:xfrm>
            <a:off x="682329" y="2505075"/>
            <a:ext cx="4190702"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Content Placeholder 5"/>
          <p:cNvSpPr>
            <a:spLocks noGrp="1"/>
          </p:cNvSpPr>
          <p:nvPr>
            <p:ph sz="quarter" idx="4"/>
          </p:nvPr>
        </p:nvSpPr>
        <p:spPr>
          <a:xfrm>
            <a:off x="5014913" y="2505075"/>
            <a:ext cx="4211340"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68748096-5A3E-4ED9-A564-DF9D8AE910A3}" type="datetimeFigureOut">
              <a:rPr lang="de-DE" smtClean="0"/>
              <a:t>16.12.20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2073199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68748096-5A3E-4ED9-A564-DF9D8AE910A3}" type="datetimeFigureOut">
              <a:rPr lang="de-DE" smtClean="0"/>
              <a:t>16.12.20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1038487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748096-5A3E-4ED9-A564-DF9D8AE910A3}" type="datetimeFigureOut">
              <a:rPr lang="de-DE" smtClean="0"/>
              <a:t>16.12.20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13666090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de-DE"/>
              <a:t>Mastertitelformat bearbeiten</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68748096-5A3E-4ED9-A564-DF9D8AE910A3}" type="datetimeFigureOut">
              <a:rPr lang="de-DE" smtClean="0"/>
              <a:t>16.1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179618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de-DE"/>
              <a:t>Mastertitelformat bearbeiten</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a:t>Bild durch Klicken auf Symbol hinzufügen</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68748096-5A3E-4ED9-A564-DF9D8AE910A3}" type="datetimeFigureOut">
              <a:rPr lang="de-DE" smtClean="0"/>
              <a:t>16.1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13FFCDC7-4603-4D57-AAFB-86F3EAC9D5EF}" type="slidenum">
              <a:rPr lang="de-DE" smtClean="0"/>
              <a:t>‹Nr.›</a:t>
            </a:fld>
            <a:endParaRPr lang="de-DE"/>
          </a:p>
        </p:txBody>
      </p:sp>
    </p:spTree>
    <p:extLst>
      <p:ext uri="{BB962C8B-B14F-4D97-AF65-F5344CB8AC3E}">
        <p14:creationId xmlns:p14="http://schemas.microsoft.com/office/powerpoint/2010/main" val="1372842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8748096-5A3E-4ED9-A564-DF9D8AE910A3}" type="datetimeFigureOut">
              <a:rPr lang="de-DE" smtClean="0"/>
              <a:t>16.12.2025</a:t>
            </a:fld>
            <a:endParaRPr lang="de-DE"/>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de-DE"/>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13FFCDC7-4603-4D57-AAFB-86F3EAC9D5EF}" type="slidenum">
              <a:rPr lang="de-DE" smtClean="0"/>
              <a:t>‹Nr.›</a:t>
            </a:fld>
            <a:endParaRPr lang="de-DE"/>
          </a:p>
        </p:txBody>
      </p:sp>
    </p:spTree>
    <p:extLst>
      <p:ext uri="{BB962C8B-B14F-4D97-AF65-F5344CB8AC3E}">
        <p14:creationId xmlns:p14="http://schemas.microsoft.com/office/powerpoint/2010/main" val="3047928421"/>
      </p:ext>
    </p:extLst>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95C9FF4F-6E34-8AC2-0691-84A6AF49ACAA}"/>
              </a:ext>
            </a:extLst>
          </p:cNvPr>
          <p:cNvSpPr txBox="1"/>
          <p:nvPr/>
        </p:nvSpPr>
        <p:spPr>
          <a:xfrm>
            <a:off x="0" y="5651638"/>
            <a:ext cx="9906000" cy="987130"/>
          </a:xfrm>
          <a:prstGeom prst="rect">
            <a:avLst/>
          </a:prstGeom>
          <a:noFill/>
        </p:spPr>
        <p:txBody>
          <a:bodyPr wrap="square">
            <a:spAutoFit/>
          </a:bodyPr>
          <a:lstStyle/>
          <a:p>
            <a:pPr algn="just">
              <a:lnSpc>
                <a:spcPct val="150000"/>
              </a:lnSpc>
              <a:spcBef>
                <a:spcPts val="831"/>
              </a:spcBef>
              <a:spcAft>
                <a:spcPts val="831"/>
              </a:spcAft>
            </a:pPr>
            <a:r>
              <a:rPr lang="en-US" sz="1000" b="1" dirty="0">
                <a:latin typeface="Arial" panose="020B0604020202020204" pitchFamily="34" charset="0"/>
                <a:ea typeface="Times New Roman" panose="02020603050405020304" pitchFamily="18" charset="0"/>
                <a:cs typeface="Arial" panose="020B0604020202020204" pitchFamily="34" charset="0"/>
              </a:rPr>
              <a:t>Supplementary Figure 8 </a:t>
            </a:r>
            <a:r>
              <a:rPr lang="en-US" sz="1000" dirty="0">
                <a:latin typeface="Arial" panose="020B0604020202020204" pitchFamily="34" charset="0"/>
                <a:ea typeface="Times New Roman" panose="02020603050405020304" pitchFamily="18" charset="0"/>
                <a:cs typeface="Arial" panose="020B0604020202020204" pitchFamily="34" charset="0"/>
              </a:rPr>
              <a:t>Detected marker-trait associations (MTA) for thousand kernel weight (TKW) identified on the chromosomes 1A-3B. The vertical black bars represent the Chromosomes and the horizontal lines the approximate position of each associated marker along the chromosome. Each dot on the right side of each chromosome represents MTA detected by one model, with colors indicating the respective method. Dots positioned to the left of each chromosome summarize the detection method by which each MTA was identified.</a:t>
            </a:r>
            <a:endParaRPr lang="de-DE" sz="1000" dirty="0">
              <a:latin typeface="Arial" panose="020B0604020202020204" pitchFamily="34" charset="0"/>
              <a:ea typeface="Times New Roman" panose="02020603050405020304" pitchFamily="18" charset="0"/>
              <a:cs typeface="Arial" panose="020B0604020202020204" pitchFamily="34" charset="0"/>
            </a:endParaRPr>
          </a:p>
        </p:txBody>
      </p:sp>
      <p:pic>
        <p:nvPicPr>
          <p:cNvPr id="4" name="Grafik 3" descr="Ein Bild, das Text, Diagramm, parallel, Reihe enthält.&#10;&#10;KI-generierte Inhalte können fehlerhaft sein.">
            <a:extLst>
              <a:ext uri="{FF2B5EF4-FFF2-40B4-BE49-F238E27FC236}">
                <a16:creationId xmlns:a16="http://schemas.microsoft.com/office/drawing/2014/main" id="{2C8A07FE-3F00-7955-BD1A-BDC298A6A81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9906000" cy="5572125"/>
          </a:xfrm>
          <a:prstGeom prst="rect">
            <a:avLst/>
          </a:prstGeom>
        </p:spPr>
      </p:pic>
    </p:spTree>
    <p:extLst>
      <p:ext uri="{BB962C8B-B14F-4D97-AF65-F5344CB8AC3E}">
        <p14:creationId xmlns:p14="http://schemas.microsoft.com/office/powerpoint/2010/main" val="1348719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015C0C-D266-7D86-0E56-291A3F0D97F8}"/>
            </a:ext>
          </a:extLst>
        </p:cNvPr>
        <p:cNvGrpSpPr/>
        <p:nvPr/>
      </p:nvGrpSpPr>
      <p:grpSpPr>
        <a:xfrm>
          <a:off x="0" y="0"/>
          <a:ext cx="0" cy="0"/>
          <a:chOff x="0" y="0"/>
          <a:chExt cx="0" cy="0"/>
        </a:xfrm>
      </p:grpSpPr>
      <p:sp>
        <p:nvSpPr>
          <p:cNvPr id="11" name="Textfeld 10">
            <a:extLst>
              <a:ext uri="{FF2B5EF4-FFF2-40B4-BE49-F238E27FC236}">
                <a16:creationId xmlns:a16="http://schemas.microsoft.com/office/drawing/2014/main" id="{B277BAB5-9A7E-0572-06F2-B0CF368C40BF}"/>
              </a:ext>
            </a:extLst>
          </p:cNvPr>
          <p:cNvSpPr txBox="1"/>
          <p:nvPr/>
        </p:nvSpPr>
        <p:spPr>
          <a:xfrm>
            <a:off x="0" y="5736843"/>
            <a:ext cx="9906000" cy="987130"/>
          </a:xfrm>
          <a:prstGeom prst="rect">
            <a:avLst/>
          </a:prstGeom>
          <a:noFill/>
        </p:spPr>
        <p:txBody>
          <a:bodyPr wrap="square">
            <a:spAutoFit/>
          </a:bodyPr>
          <a:lstStyle/>
          <a:p>
            <a:pPr algn="just">
              <a:lnSpc>
                <a:spcPct val="150000"/>
              </a:lnSpc>
              <a:spcBef>
                <a:spcPts val="1200"/>
              </a:spcBef>
              <a:spcAft>
                <a:spcPts val="1200"/>
              </a:spcAft>
            </a:pPr>
            <a:r>
              <a:rPr lang="en-US" sz="1000" b="1" dirty="0">
                <a:latin typeface="Arial" panose="020B0604020202020204" pitchFamily="34" charset="0"/>
                <a:ea typeface="Times New Roman" panose="02020603050405020304" pitchFamily="18" charset="0"/>
                <a:cs typeface="Arial" panose="020B0604020202020204" pitchFamily="34" charset="0"/>
              </a:rPr>
              <a:t>Supplementary Figure 9 </a:t>
            </a:r>
            <a:r>
              <a:rPr lang="en-US" sz="1000" dirty="0">
                <a:latin typeface="Arial" panose="020B0604020202020204" pitchFamily="34" charset="0"/>
                <a:ea typeface="Times New Roman" panose="02020603050405020304" pitchFamily="18" charset="0"/>
                <a:cs typeface="Arial" panose="020B0604020202020204" pitchFamily="34" charset="0"/>
              </a:rPr>
              <a:t>Detected marker-trait associations (MTA) for thousand kernel weight (TKW) identified on the chromosomes 3D-5D. The vertical black bars represent the Chromosomes and the horizontal lines the approximate position of each associated marker along the chromosome. Each dot on the right side of each chromosome represents MTA detected by one model, with colors indicating the respective method. Dots positioned to the left of each chromosome summarize the detection method by which each MTA was identified.</a:t>
            </a:r>
            <a:endParaRPr lang="de-DE" sz="10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4" name="Grafik 3" descr="Ein Bild, das Text, Diagramm, Reihe, Screenshot enthält.&#10;&#10;KI-generierte Inhalte können fehlerhaft sein.">
            <a:extLst>
              <a:ext uri="{FF2B5EF4-FFF2-40B4-BE49-F238E27FC236}">
                <a16:creationId xmlns:a16="http://schemas.microsoft.com/office/drawing/2014/main" id="{8EB91D89-8803-440B-4DA0-EAA3046E7BE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906000" cy="5572125"/>
          </a:xfrm>
          <a:prstGeom prst="rect">
            <a:avLst/>
          </a:prstGeom>
        </p:spPr>
      </p:pic>
    </p:spTree>
    <p:extLst>
      <p:ext uri="{BB962C8B-B14F-4D97-AF65-F5344CB8AC3E}">
        <p14:creationId xmlns:p14="http://schemas.microsoft.com/office/powerpoint/2010/main" val="14388076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29A8DD-7F7C-D1AE-F09A-F10E9F37AA0D}"/>
            </a:ext>
          </a:extLst>
        </p:cNvPr>
        <p:cNvGrpSpPr/>
        <p:nvPr/>
      </p:nvGrpSpPr>
      <p:grpSpPr>
        <a:xfrm>
          <a:off x="0" y="0"/>
          <a:ext cx="0" cy="0"/>
          <a:chOff x="0" y="0"/>
          <a:chExt cx="0" cy="0"/>
        </a:xfrm>
      </p:grpSpPr>
      <p:sp>
        <p:nvSpPr>
          <p:cNvPr id="11" name="Textfeld 10">
            <a:extLst>
              <a:ext uri="{FF2B5EF4-FFF2-40B4-BE49-F238E27FC236}">
                <a16:creationId xmlns:a16="http://schemas.microsoft.com/office/drawing/2014/main" id="{BD1A018C-A669-B098-F971-00A3A859B060}"/>
              </a:ext>
            </a:extLst>
          </p:cNvPr>
          <p:cNvSpPr txBox="1"/>
          <p:nvPr/>
        </p:nvSpPr>
        <p:spPr>
          <a:xfrm>
            <a:off x="0" y="5736843"/>
            <a:ext cx="9906000" cy="1525739"/>
          </a:xfrm>
          <a:prstGeom prst="rect">
            <a:avLst/>
          </a:prstGeom>
          <a:noFill/>
        </p:spPr>
        <p:txBody>
          <a:bodyPr wrap="square">
            <a:spAutoFit/>
          </a:bodyPr>
          <a:lstStyle/>
          <a:p>
            <a:pPr algn="just">
              <a:lnSpc>
                <a:spcPct val="150000"/>
              </a:lnSpc>
              <a:spcBef>
                <a:spcPts val="1200"/>
              </a:spcBef>
              <a:spcAft>
                <a:spcPts val="1200"/>
              </a:spcAft>
            </a:pPr>
            <a:r>
              <a:rPr lang="en-US" sz="1000" b="1" dirty="0">
                <a:latin typeface="Arial" panose="020B0604020202020204" pitchFamily="34" charset="0"/>
                <a:ea typeface="Times New Roman" panose="02020603050405020304" pitchFamily="18" charset="0"/>
                <a:cs typeface="Arial" panose="020B0604020202020204" pitchFamily="34" charset="0"/>
              </a:rPr>
              <a:t>Supplementary Figure 10 </a:t>
            </a:r>
            <a:r>
              <a:rPr lang="en-US" sz="1000" dirty="0">
                <a:latin typeface="Arial" panose="020B0604020202020204" pitchFamily="34" charset="0"/>
                <a:ea typeface="Times New Roman" panose="02020603050405020304" pitchFamily="18" charset="0"/>
                <a:cs typeface="Arial" panose="020B0604020202020204" pitchFamily="34" charset="0"/>
              </a:rPr>
              <a:t>Detected marker-trait associations (MTA) for thousand kernel weight (TKW) identified on the chromosomes 6A-7D. The vertical black bars represent the Chromosomes and the horizontal lines the approximate position of each associated marker along the chromosome. Each dot on the right side of each chromosome represents MTA detected by one model, with colors indicating the respective method. Dots positioned to the left of each chromosome summarize the detection method by which each MTA was identified.</a:t>
            </a:r>
            <a:endParaRPr lang="de-DE" sz="1000" dirty="0">
              <a:latin typeface="Arial" panose="020B0604020202020204" pitchFamily="34" charset="0"/>
              <a:ea typeface="Times New Roman" panose="02020603050405020304" pitchFamily="18" charset="0"/>
              <a:cs typeface="Arial" panose="020B0604020202020204" pitchFamily="34" charset="0"/>
            </a:endParaRPr>
          </a:p>
          <a:p>
            <a:pPr algn="just">
              <a:lnSpc>
                <a:spcPct val="150000"/>
              </a:lnSpc>
              <a:spcBef>
                <a:spcPts val="1200"/>
              </a:spcBef>
              <a:spcAft>
                <a:spcPts val="1200"/>
              </a:spcAft>
            </a:pPr>
            <a:endParaRPr lang="de-DE" sz="10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3" name="Grafik 2" descr="Ein Bild, das Text, Diagramm, Screenshot, Reihe enthält.&#10;&#10;KI-generierte Inhalte können fehlerhaft sein.">
            <a:extLst>
              <a:ext uri="{FF2B5EF4-FFF2-40B4-BE49-F238E27FC236}">
                <a16:creationId xmlns:a16="http://schemas.microsoft.com/office/drawing/2014/main" id="{21158876-9140-E417-D915-D4AF8FAE03B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906000" cy="5572125"/>
          </a:xfrm>
          <a:prstGeom prst="rect">
            <a:avLst/>
          </a:prstGeom>
        </p:spPr>
      </p:pic>
    </p:spTree>
    <p:extLst>
      <p:ext uri="{BB962C8B-B14F-4D97-AF65-F5344CB8AC3E}">
        <p14:creationId xmlns:p14="http://schemas.microsoft.com/office/powerpoint/2010/main" val="32884577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19461C1-A340-A73D-AB3F-73431DB60677}"/>
            </a:ext>
          </a:extLst>
        </p:cNvPr>
        <p:cNvGrpSpPr/>
        <p:nvPr/>
      </p:nvGrpSpPr>
      <p:grpSpPr>
        <a:xfrm>
          <a:off x="0" y="0"/>
          <a:ext cx="0" cy="0"/>
          <a:chOff x="0" y="0"/>
          <a:chExt cx="0" cy="0"/>
        </a:xfrm>
      </p:grpSpPr>
      <p:sp>
        <p:nvSpPr>
          <p:cNvPr id="11" name="Textfeld 10">
            <a:extLst>
              <a:ext uri="{FF2B5EF4-FFF2-40B4-BE49-F238E27FC236}">
                <a16:creationId xmlns:a16="http://schemas.microsoft.com/office/drawing/2014/main" id="{DA131EDF-EC6B-C484-9218-537735E4388C}"/>
              </a:ext>
            </a:extLst>
          </p:cNvPr>
          <p:cNvSpPr txBox="1"/>
          <p:nvPr/>
        </p:nvSpPr>
        <p:spPr>
          <a:xfrm>
            <a:off x="0" y="5736843"/>
            <a:ext cx="9906000" cy="987130"/>
          </a:xfrm>
          <a:prstGeom prst="rect">
            <a:avLst/>
          </a:prstGeom>
          <a:noFill/>
        </p:spPr>
        <p:txBody>
          <a:bodyPr wrap="square">
            <a:spAutoFit/>
          </a:bodyPr>
          <a:lstStyle/>
          <a:p>
            <a:pPr algn="just">
              <a:lnSpc>
                <a:spcPct val="150000"/>
              </a:lnSpc>
              <a:spcBef>
                <a:spcPts val="1200"/>
              </a:spcBef>
              <a:spcAft>
                <a:spcPts val="1200"/>
              </a:spcAft>
            </a:pPr>
            <a:r>
              <a:rPr lang="en-US" sz="1000" b="1" dirty="0">
                <a:latin typeface="Arial" panose="020B0604020202020204" pitchFamily="34" charset="0"/>
                <a:ea typeface="Times New Roman" panose="02020603050405020304" pitchFamily="18" charset="0"/>
                <a:cs typeface="Arial" panose="020B0604020202020204" pitchFamily="34" charset="0"/>
              </a:rPr>
              <a:t>Supplementary Figure 11 </a:t>
            </a:r>
            <a:r>
              <a:rPr lang="en-US" sz="1000" dirty="0">
                <a:latin typeface="Arial" panose="020B0604020202020204" pitchFamily="34" charset="0"/>
                <a:ea typeface="Times New Roman" panose="02020603050405020304" pitchFamily="18" charset="0"/>
                <a:cs typeface="Arial" panose="020B0604020202020204" pitchFamily="34" charset="0"/>
              </a:rPr>
              <a:t>Detected marker-trait associations (MTA) for plant height (PH) identified on the chromosomes 1A-3A. The vertical black bars represent the Chromosomes and the horizontal lines the approximate position of each associated marker along the chromosome. Each dot on the right side of each chromosome represents MTA detected by one model, with colors indicating the respective method. Dots positioned to the left of each chromosome summarize the detection method by which each MTA was identified.</a:t>
            </a:r>
            <a:endParaRPr lang="de-DE" sz="10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3" name="Grafik 2" descr="Ein Bild, das Text, Diagramm, Screenshot, Reihe enthält.&#10;&#10;KI-generierte Inhalte können fehlerhaft sein.">
            <a:extLst>
              <a:ext uri="{FF2B5EF4-FFF2-40B4-BE49-F238E27FC236}">
                <a16:creationId xmlns:a16="http://schemas.microsoft.com/office/drawing/2014/main" id="{8ECFD058-BE7D-7284-F46B-7DB129E5618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906000" cy="5572125"/>
          </a:xfrm>
          <a:prstGeom prst="rect">
            <a:avLst/>
          </a:prstGeom>
        </p:spPr>
      </p:pic>
    </p:spTree>
    <p:extLst>
      <p:ext uri="{BB962C8B-B14F-4D97-AF65-F5344CB8AC3E}">
        <p14:creationId xmlns:p14="http://schemas.microsoft.com/office/powerpoint/2010/main" val="39837639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41193A0-71E2-438E-04AD-498CEDBEC902}"/>
            </a:ext>
          </a:extLst>
        </p:cNvPr>
        <p:cNvGrpSpPr/>
        <p:nvPr/>
      </p:nvGrpSpPr>
      <p:grpSpPr>
        <a:xfrm>
          <a:off x="0" y="0"/>
          <a:ext cx="0" cy="0"/>
          <a:chOff x="0" y="0"/>
          <a:chExt cx="0" cy="0"/>
        </a:xfrm>
      </p:grpSpPr>
      <p:sp>
        <p:nvSpPr>
          <p:cNvPr id="11" name="Textfeld 10">
            <a:extLst>
              <a:ext uri="{FF2B5EF4-FFF2-40B4-BE49-F238E27FC236}">
                <a16:creationId xmlns:a16="http://schemas.microsoft.com/office/drawing/2014/main" id="{F69B3333-07E9-BD71-1C1D-B3FA7EF6A4C5}"/>
              </a:ext>
            </a:extLst>
          </p:cNvPr>
          <p:cNvSpPr txBox="1"/>
          <p:nvPr/>
        </p:nvSpPr>
        <p:spPr>
          <a:xfrm>
            <a:off x="0" y="5736843"/>
            <a:ext cx="9906000" cy="987130"/>
          </a:xfrm>
          <a:prstGeom prst="rect">
            <a:avLst/>
          </a:prstGeom>
          <a:noFill/>
        </p:spPr>
        <p:txBody>
          <a:bodyPr wrap="square">
            <a:spAutoFit/>
          </a:bodyPr>
          <a:lstStyle/>
          <a:p>
            <a:pPr algn="just">
              <a:lnSpc>
                <a:spcPct val="150000"/>
              </a:lnSpc>
              <a:spcBef>
                <a:spcPts val="1200"/>
              </a:spcBef>
              <a:spcAft>
                <a:spcPts val="1200"/>
              </a:spcAft>
            </a:pPr>
            <a:r>
              <a:rPr lang="en-US" sz="1000" b="1" dirty="0">
                <a:latin typeface="Arial" panose="020B0604020202020204" pitchFamily="34" charset="0"/>
                <a:ea typeface="Times New Roman" panose="02020603050405020304" pitchFamily="18" charset="0"/>
                <a:cs typeface="Arial" panose="020B0604020202020204" pitchFamily="34" charset="0"/>
              </a:rPr>
              <a:t>Supplementary Figure 12 </a:t>
            </a:r>
            <a:r>
              <a:rPr lang="en-US" sz="1000" dirty="0">
                <a:latin typeface="Arial" panose="020B0604020202020204" pitchFamily="34" charset="0"/>
                <a:ea typeface="Times New Roman" panose="02020603050405020304" pitchFamily="18" charset="0"/>
                <a:cs typeface="Arial" panose="020B0604020202020204" pitchFamily="34" charset="0"/>
              </a:rPr>
              <a:t>Detected marker-trait associations (MTA) for plant height (PH) identified on the chromosomes 3B-5B. The vertical black bars represent the Chromosomes and the horizontal lines the approximate position of each associated marker along the chromosome. Each dot on the right side of each chromosome represents MTA detected by one model, with colors indicating the respective method. Dots positioned to the left of each chromosome summarize the detection method by which each MTA was identified.</a:t>
            </a:r>
            <a:endParaRPr lang="de-DE" sz="10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4" name="Grafik 3" descr="Ein Bild, das Text, Diagramm, Screenshot, Reihe enthält.&#10;&#10;KI-generierte Inhalte können fehlerhaft sein.">
            <a:extLst>
              <a:ext uri="{FF2B5EF4-FFF2-40B4-BE49-F238E27FC236}">
                <a16:creationId xmlns:a16="http://schemas.microsoft.com/office/drawing/2014/main" id="{2901D450-4414-9FF0-F035-461F60D1E86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906000" cy="5572125"/>
          </a:xfrm>
          <a:prstGeom prst="rect">
            <a:avLst/>
          </a:prstGeom>
        </p:spPr>
      </p:pic>
    </p:spTree>
    <p:extLst>
      <p:ext uri="{BB962C8B-B14F-4D97-AF65-F5344CB8AC3E}">
        <p14:creationId xmlns:p14="http://schemas.microsoft.com/office/powerpoint/2010/main" val="18153344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B847B51-80AD-A27F-2FC4-210D0710D159}"/>
            </a:ext>
          </a:extLst>
        </p:cNvPr>
        <p:cNvGrpSpPr/>
        <p:nvPr/>
      </p:nvGrpSpPr>
      <p:grpSpPr>
        <a:xfrm>
          <a:off x="0" y="0"/>
          <a:ext cx="0" cy="0"/>
          <a:chOff x="0" y="0"/>
          <a:chExt cx="0" cy="0"/>
        </a:xfrm>
      </p:grpSpPr>
      <p:sp>
        <p:nvSpPr>
          <p:cNvPr id="11" name="Textfeld 10">
            <a:extLst>
              <a:ext uri="{FF2B5EF4-FFF2-40B4-BE49-F238E27FC236}">
                <a16:creationId xmlns:a16="http://schemas.microsoft.com/office/drawing/2014/main" id="{06463492-DF91-9630-8419-05B7F3B165AE}"/>
              </a:ext>
            </a:extLst>
          </p:cNvPr>
          <p:cNvSpPr txBox="1"/>
          <p:nvPr/>
        </p:nvSpPr>
        <p:spPr>
          <a:xfrm>
            <a:off x="0" y="5736843"/>
            <a:ext cx="9906000" cy="987130"/>
          </a:xfrm>
          <a:prstGeom prst="rect">
            <a:avLst/>
          </a:prstGeom>
          <a:noFill/>
        </p:spPr>
        <p:txBody>
          <a:bodyPr wrap="square">
            <a:spAutoFit/>
          </a:bodyPr>
          <a:lstStyle/>
          <a:p>
            <a:pPr algn="just">
              <a:lnSpc>
                <a:spcPct val="150000"/>
              </a:lnSpc>
              <a:spcBef>
                <a:spcPts val="831"/>
              </a:spcBef>
              <a:spcAft>
                <a:spcPts val="831"/>
              </a:spcAft>
            </a:pPr>
            <a:r>
              <a:rPr lang="en-US" sz="1000" b="1" dirty="0">
                <a:latin typeface="Arial" panose="020B0604020202020204" pitchFamily="34" charset="0"/>
                <a:ea typeface="Times New Roman" panose="02020603050405020304" pitchFamily="18" charset="0"/>
                <a:cs typeface="Arial" panose="020B0604020202020204" pitchFamily="34" charset="0"/>
              </a:rPr>
              <a:t>Supplementary Figure 13 </a:t>
            </a:r>
            <a:r>
              <a:rPr lang="en-US" sz="1000" dirty="0">
                <a:latin typeface="Arial" panose="020B0604020202020204" pitchFamily="34" charset="0"/>
                <a:ea typeface="Times New Roman" panose="02020603050405020304" pitchFamily="18" charset="0"/>
                <a:cs typeface="Arial" panose="020B0604020202020204" pitchFamily="34" charset="0"/>
              </a:rPr>
              <a:t>Detected marker-trait associations (MTA) for plant height (PH) identified on the chromosomes 6A-7D. The vertical black bars represent the Chromosomes and the horizontal lines the approximate position of each associated marker along the chromosome. Each dot on the right side of each chromosome represents MTA detected by one model, with colors indicating the respective method. Dots positioned to the left of each chromosome summarize the detection method by which each MTA was identified.</a:t>
            </a:r>
            <a:endParaRPr lang="de-DE" sz="1000" dirty="0">
              <a:latin typeface="Arial" panose="020B0604020202020204" pitchFamily="34" charset="0"/>
              <a:ea typeface="Times New Roman" panose="02020603050405020304" pitchFamily="18" charset="0"/>
              <a:cs typeface="Arial" panose="020B0604020202020204" pitchFamily="34" charset="0"/>
            </a:endParaRPr>
          </a:p>
        </p:txBody>
      </p:sp>
      <p:pic>
        <p:nvPicPr>
          <p:cNvPr id="6" name="Grafik 5" descr="Ein Bild, das Text, Diagramm, Screenshot, parallel enthält.&#10;&#10;KI-generierte Inhalte können fehlerhaft sein.">
            <a:extLst>
              <a:ext uri="{FF2B5EF4-FFF2-40B4-BE49-F238E27FC236}">
                <a16:creationId xmlns:a16="http://schemas.microsoft.com/office/drawing/2014/main" id="{CED2C8BC-74DF-38BD-FA74-300A84EB78F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906000" cy="5572125"/>
          </a:xfrm>
          <a:prstGeom prst="rect">
            <a:avLst/>
          </a:prstGeom>
        </p:spPr>
      </p:pic>
    </p:spTree>
    <p:extLst>
      <p:ext uri="{BB962C8B-B14F-4D97-AF65-F5344CB8AC3E}">
        <p14:creationId xmlns:p14="http://schemas.microsoft.com/office/powerpoint/2010/main" val="38577611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a:extLst>
              <a:ext uri="{FF2B5EF4-FFF2-40B4-BE49-F238E27FC236}">
                <a16:creationId xmlns:a16="http://schemas.microsoft.com/office/drawing/2014/main" id="{91670905-630A-F747-049E-7BCC5FE6BBA5}"/>
              </a:ext>
            </a:extLst>
          </p:cNvPr>
          <p:cNvSpPr txBox="1"/>
          <p:nvPr/>
        </p:nvSpPr>
        <p:spPr>
          <a:xfrm>
            <a:off x="0" y="5640038"/>
            <a:ext cx="9814560" cy="987130"/>
          </a:xfrm>
          <a:prstGeom prst="rect">
            <a:avLst/>
          </a:prstGeom>
          <a:noFill/>
        </p:spPr>
        <p:txBody>
          <a:bodyPr wrap="square">
            <a:spAutoFit/>
          </a:bodyPr>
          <a:lstStyle/>
          <a:p>
            <a:pPr algn="just">
              <a:lnSpc>
                <a:spcPct val="150000"/>
              </a:lnSpc>
              <a:spcBef>
                <a:spcPts val="831"/>
              </a:spcBef>
              <a:spcAft>
                <a:spcPts val="831"/>
              </a:spcAft>
            </a:pPr>
            <a:r>
              <a:rPr lang="en-US" sz="1000" b="1" dirty="0">
                <a:latin typeface="Arial" panose="020B0604020202020204" pitchFamily="34" charset="0"/>
                <a:cs typeface="Arial" panose="020B0604020202020204" pitchFamily="34" charset="0"/>
              </a:rPr>
              <a:t>Supplementary Figure 14 </a:t>
            </a:r>
            <a:r>
              <a:rPr lang="en-US" sz="1000" dirty="0">
                <a:latin typeface="Arial" panose="020B0604020202020204" pitchFamily="34" charset="0"/>
                <a:cs typeface="Arial" panose="020B0604020202020204" pitchFamily="34" charset="0"/>
              </a:rPr>
              <a:t>Pairwise McNemar test results comparing marker-trait association (MTA) detection among GWAS methods for thousand kernel weight (TKW). Heatmap cells display McNemar test p-values based on the overlap of detected MTAs between method pairs, with lower values (red) indicating significantly different MTA sets and higher values (blue) indicating greater overlap. Grey cells indicate self-comparisons or cases where the McNemar test was not applicable due to insufficient discordant MTAs. Significance levels are denoted as </a:t>
            </a:r>
            <a:r>
              <a:rPr lang="nn-NO" sz="1000" dirty="0">
                <a:latin typeface="Arial" panose="020B0604020202020204" pitchFamily="34" charset="0"/>
                <a:cs typeface="Arial" panose="020B0604020202020204" pitchFamily="34" charset="0"/>
              </a:rPr>
              <a:t>(* p &lt; 0.05, ** p &lt; 0.01, *** p &lt; 0.001).</a:t>
            </a:r>
            <a:endParaRPr lang="de-DE" sz="1000" dirty="0">
              <a:latin typeface="Arial" panose="020B0604020202020204" pitchFamily="34" charset="0"/>
              <a:cs typeface="Arial" panose="020B0604020202020204" pitchFamily="34" charset="0"/>
            </a:endParaRPr>
          </a:p>
        </p:txBody>
      </p:sp>
      <p:pic>
        <p:nvPicPr>
          <p:cNvPr id="4" name="Grafik 3" descr="Ein Bild, das Text, Screenshot, Diagramm enthält.&#10;&#10;KI-generierte Inhalte können fehlerhaft sein.">
            <a:extLst>
              <a:ext uri="{FF2B5EF4-FFF2-40B4-BE49-F238E27FC236}">
                <a16:creationId xmlns:a16="http://schemas.microsoft.com/office/drawing/2014/main" id="{DDC25600-5E0D-6101-643A-8369BB8CB60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09931" y="0"/>
            <a:ext cx="7594697" cy="5720400"/>
          </a:xfrm>
          <a:prstGeom prst="rect">
            <a:avLst/>
          </a:prstGeom>
        </p:spPr>
      </p:pic>
    </p:spTree>
    <p:extLst>
      <p:ext uri="{BB962C8B-B14F-4D97-AF65-F5344CB8AC3E}">
        <p14:creationId xmlns:p14="http://schemas.microsoft.com/office/powerpoint/2010/main" val="181746891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AE8D3AB9-5EFA-62C9-CA4A-B74C0B6BAB4A}"/>
              </a:ext>
            </a:extLst>
          </p:cNvPr>
          <p:cNvSpPr txBox="1"/>
          <p:nvPr/>
        </p:nvSpPr>
        <p:spPr>
          <a:xfrm>
            <a:off x="0" y="5865934"/>
            <a:ext cx="9814560" cy="987130"/>
          </a:xfrm>
          <a:prstGeom prst="rect">
            <a:avLst/>
          </a:prstGeom>
          <a:noFill/>
        </p:spPr>
        <p:txBody>
          <a:bodyPr wrap="square">
            <a:spAutoFit/>
          </a:bodyPr>
          <a:lstStyle/>
          <a:p>
            <a:pPr algn="just">
              <a:lnSpc>
                <a:spcPct val="150000"/>
              </a:lnSpc>
              <a:spcBef>
                <a:spcPts val="831"/>
              </a:spcBef>
              <a:spcAft>
                <a:spcPts val="831"/>
              </a:spcAft>
            </a:pPr>
            <a:r>
              <a:rPr lang="en-US" sz="1000" b="1" dirty="0">
                <a:latin typeface="Arial" panose="020B0604020202020204" pitchFamily="34" charset="0"/>
                <a:cs typeface="Arial" panose="020B0604020202020204" pitchFamily="34" charset="0"/>
              </a:rPr>
              <a:t>Supplementary Figure 15 </a:t>
            </a:r>
            <a:r>
              <a:rPr lang="en-US" sz="1000" dirty="0">
                <a:latin typeface="Arial" panose="020B0604020202020204" pitchFamily="34" charset="0"/>
                <a:cs typeface="Arial" panose="020B0604020202020204" pitchFamily="34" charset="0"/>
              </a:rPr>
              <a:t>Pairwise McNemar test results comparing marker-trait association (MTA) detection among GWAS methods for plant height (PH). Heatmap cells display McNemar test p-values based on the overlap of detected MTAs between method pairs, with lower values (red) indicating significantly different MTA sets and higher values (blue) indicating greater overlap. Grey cells indicate self-comparisons or cases where the McNemar test was not applicable due to insufficient discordant MTAs. Significance levels are denoted as </a:t>
            </a:r>
            <a:r>
              <a:rPr lang="nn-NO" sz="1000" dirty="0">
                <a:latin typeface="Arial" panose="020B0604020202020204" pitchFamily="34" charset="0"/>
                <a:cs typeface="Arial" panose="020B0604020202020204" pitchFamily="34" charset="0"/>
              </a:rPr>
              <a:t>(* p &lt; 0.05, ** p &lt; 0.01, *** p &lt; 0.001).</a:t>
            </a:r>
            <a:endParaRPr lang="de-DE" sz="1000" dirty="0">
              <a:latin typeface="Arial" panose="020B0604020202020204" pitchFamily="34" charset="0"/>
              <a:cs typeface="Arial" panose="020B0604020202020204" pitchFamily="34" charset="0"/>
            </a:endParaRPr>
          </a:p>
        </p:txBody>
      </p:sp>
      <p:pic>
        <p:nvPicPr>
          <p:cNvPr id="5" name="Grafik 4" descr="Ein Bild, das Text, Screenshot, Diagramm, Farbigkeit enthält.&#10;&#10;KI-generierte Inhalte können fehlerhaft sein.">
            <a:extLst>
              <a:ext uri="{FF2B5EF4-FFF2-40B4-BE49-F238E27FC236}">
                <a16:creationId xmlns:a16="http://schemas.microsoft.com/office/drawing/2014/main" id="{523720E9-E453-6F60-3B21-E93E1A8807F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56239" y="0"/>
            <a:ext cx="7593521" cy="5719514"/>
          </a:xfrm>
          <a:prstGeom prst="rect">
            <a:avLst/>
          </a:prstGeom>
        </p:spPr>
      </p:pic>
    </p:spTree>
    <p:extLst>
      <p:ext uri="{BB962C8B-B14F-4D97-AF65-F5344CB8AC3E}">
        <p14:creationId xmlns:p14="http://schemas.microsoft.com/office/powerpoint/2010/main" val="2690825949"/>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715</Words>
  <Application>Microsoft Office PowerPoint</Application>
  <PresentationFormat>A4-Papier (210 x 297 mm)</PresentationFormat>
  <Paragraphs>9</Paragraphs>
  <Slides>8</Slides>
  <Notes>1</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8</vt:i4>
      </vt:variant>
    </vt:vector>
  </HeadingPairs>
  <TitlesOfParts>
    <vt:vector size="12" baseType="lpstr">
      <vt:lpstr>Aptos</vt:lpstr>
      <vt:lpstr>Aptos Display</vt:lpstr>
      <vt:lpstr>Arial</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lek Joel</dc:creator>
  <cp:lastModifiedBy>Milek Joel</cp:lastModifiedBy>
  <cp:revision>3</cp:revision>
  <dcterms:created xsi:type="dcterms:W3CDTF">2025-06-30T11:21:50Z</dcterms:created>
  <dcterms:modified xsi:type="dcterms:W3CDTF">2025-12-16T08:44:25Z</dcterms:modified>
</cp:coreProperties>
</file>